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83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FA2BCF-1919-7042-E51D-7510C50E145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5CB01D3-E012-F07B-EA50-76F8C75771E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496353-8714-650B-1391-377064DF66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336B8-ADB6-4F01-B245-697E68BE11C2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5C3786-F87E-5BA4-D9FB-ED2F7DE7A9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1173D3-3E64-0CDF-438D-9A98ABE8CF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73103-C351-4F20-9281-C4E41EA339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8104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6F75E5-40C1-9C2A-5B81-7BD9E7F2AC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17F8049-7354-1434-A46F-CB5C393A7B8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3D3040-00C9-84CA-BB43-C4504DBB45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336B8-ADB6-4F01-B245-697E68BE11C2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BB9011-96ED-DFD9-B4DC-F0E84E0C83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015568-02A6-8FE2-FBC0-C80CD7FCFB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73103-C351-4F20-9281-C4E41EA339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61237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9558A06-E3DF-8CCE-4D06-F0029E12306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3204C88-520C-C224-D864-2DB6276389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EA261E-EE48-C0CD-F14D-20D9A26909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336B8-ADB6-4F01-B245-697E68BE11C2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DDB4B5-C421-E77C-72E6-AF2AB91AAA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E709E9-E32A-E10A-61CA-F0D79F7D7B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73103-C351-4F20-9281-C4E41EA339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82071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5D1B45-BBCA-C26A-C118-57D0C59EB5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451158B-E324-7D50-8116-6BE7E13FAB6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35769B-574F-E0A5-E57C-5AB6181103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336B8-ADB6-4F01-B245-697E68BE11C2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BEE8C8-FE78-C13F-6EEA-EA3D749864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095C3F-5A57-98ED-3145-99588FEE9B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73103-C351-4F20-9281-C4E41EA339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93996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E5DD68-3B7F-F088-C6E9-9EA7CABEC1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FD66953-E15B-C604-2B48-8891B1C2F1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A33C66-5788-853F-62DB-55C6F3D2C9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336B8-ADB6-4F01-B245-697E68BE11C2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C065B2-CBD2-B33F-47EE-3B57B81710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4822C4-1641-3111-6F9B-695AB64B52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73103-C351-4F20-9281-C4E41EA339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63554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9AC9A2-81AC-004A-2D6E-CA1C26FA17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BEFE03-08EC-A35D-1362-A4AEF2C491C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9DDA119-3889-3D10-1AD4-0D7D6911050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8083862-8DE6-C170-CD1E-E4711A161C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336B8-ADB6-4F01-B245-697E68BE11C2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1C66712-C604-1526-EF00-735D2019D7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6346647-D376-0492-6201-20A04D611F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73103-C351-4F20-9281-C4E41EA339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42048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9309BD-5A1E-4B99-9C68-BBAB6D9144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331BF0-64A7-9568-D157-2BE2D71EFC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EEC4FFD-1EAB-5441-FE99-B4AC170667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D64DE3B-606D-AA3B-3B9A-68EE915539D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13CCDC1-179E-E94D-2F9C-2FEE7B9A289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B5C0A3D-8FD0-D899-EC10-4ED817AA9D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336B8-ADB6-4F01-B245-697E68BE11C2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A8ED12A-3416-08E0-70A6-41436840FD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7EEB334-9F12-55B9-83C6-A094339ED1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73103-C351-4F20-9281-C4E41EA339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1586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DBAA90-6263-BFF0-644B-CBBE6D9532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EF6466E-ACF6-84EC-503F-04C9723B4C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336B8-ADB6-4F01-B245-697E68BE11C2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8E4E9AC-E9B5-9165-E64B-26F8447807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56D7B61-C8DF-0DDB-1D8E-2A21F45D54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73103-C351-4F20-9281-C4E41EA339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3938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01FBFDC-A3AA-4897-553B-1C1800AED5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336B8-ADB6-4F01-B245-697E68BE11C2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015C92A-E673-5EDE-8662-44916D2384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26F9C90-F7A7-3112-F12A-A22ACE0B2E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73103-C351-4F20-9281-C4E41EA339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06071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64E5D2-DBB6-2F51-0242-20602B543B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C4C239-9784-456B-06B1-74DA113B261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DCA14C0-1D86-427A-63E8-3493C3B31D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68DEFFB-489B-E571-E409-9F954074B5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336B8-ADB6-4F01-B245-697E68BE11C2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D6E57F9-DE20-92D9-5DFA-2B2CCA5FA4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6FD56CA-C288-EE9F-D631-F5DF735D06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73103-C351-4F20-9281-C4E41EA339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13569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03DF37-8BC6-32BF-9E7C-B2C4C380B1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000762E-72C2-D4C2-4797-2689C0BF19C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8ADB044-C72C-C4E0-6D13-63760EE2611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9946094-C553-6A48-0E1A-1CAC9283D1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336B8-ADB6-4F01-B245-697E68BE11C2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DAFF5DA-7286-FCB5-C251-5C6A27F163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AD2D0A1-1935-1C62-19E7-00B6DAB34A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73103-C351-4F20-9281-C4E41EA339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61538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2286D26-F120-E5B3-3BAA-2A67198CD8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2AACC7A-CE66-6DA1-380C-F81A4477FA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FF9EC3-F3F1-4E53-D66E-70394956459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85336B8-ADB6-4F01-B245-697E68BE11C2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081CC2-8C2B-5924-6BEA-AF172247B1E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034048-B03A-EF97-8A2E-31620246661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4673103-C351-4F20-9281-C4E41EA339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5698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/>
        </p:nvGraphicFramePr>
        <p:xfrm>
          <a:off x="1346699" y="429650"/>
          <a:ext cx="5913083" cy="6166354"/>
        </p:xfrm>
        <a:graphic>
          <a:graphicData uri="http://schemas.openxmlformats.org/drawingml/2006/table">
            <a:tbl>
              <a:tblPr/>
              <a:tblGrid>
                <a:gridCol w="802659">
                  <a:extLst>
                    <a:ext uri="{9D8B030D-6E8A-4147-A177-3AD203B41FA5}">
                      <a16:colId xmlns:a16="http://schemas.microsoft.com/office/drawing/2014/main" val="1913865956"/>
                    </a:ext>
                  </a:extLst>
                </a:gridCol>
                <a:gridCol w="859990">
                  <a:extLst>
                    <a:ext uri="{9D8B030D-6E8A-4147-A177-3AD203B41FA5}">
                      <a16:colId xmlns:a16="http://schemas.microsoft.com/office/drawing/2014/main" val="1656345730"/>
                    </a:ext>
                  </a:extLst>
                </a:gridCol>
                <a:gridCol w="898212">
                  <a:extLst>
                    <a:ext uri="{9D8B030D-6E8A-4147-A177-3AD203B41FA5}">
                      <a16:colId xmlns:a16="http://schemas.microsoft.com/office/drawing/2014/main" val="2957781634"/>
                    </a:ext>
                  </a:extLst>
                </a:gridCol>
                <a:gridCol w="1051098">
                  <a:extLst>
                    <a:ext uri="{9D8B030D-6E8A-4147-A177-3AD203B41FA5}">
                      <a16:colId xmlns:a16="http://schemas.microsoft.com/office/drawing/2014/main" val="4062417405"/>
                    </a:ext>
                  </a:extLst>
                </a:gridCol>
                <a:gridCol w="1315610">
                  <a:extLst>
                    <a:ext uri="{9D8B030D-6E8A-4147-A177-3AD203B41FA5}">
                      <a16:colId xmlns:a16="http://schemas.microsoft.com/office/drawing/2014/main" val="1778006277"/>
                    </a:ext>
                  </a:extLst>
                </a:gridCol>
                <a:gridCol w="985514">
                  <a:extLst>
                    <a:ext uri="{9D8B030D-6E8A-4147-A177-3AD203B41FA5}">
                      <a16:colId xmlns:a16="http://schemas.microsoft.com/office/drawing/2014/main" val="718941148"/>
                    </a:ext>
                  </a:extLst>
                </a:gridCol>
              </a:tblGrid>
              <a:tr h="182031"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ay</a:t>
                      </a:r>
                      <a:r>
                        <a:rPr lang="en-US" sz="11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atter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hite</a:t>
                      </a:r>
                      <a:r>
                        <a:rPr lang="en-US" sz="11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atter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90402586"/>
                  </a:ext>
                </a:extLst>
              </a:tr>
              <a:tr h="181714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ts 1&amp;2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t 2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ts 3&amp;4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t</a:t>
                      </a:r>
                      <a:r>
                        <a:rPr lang="en-US" sz="11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5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18818057"/>
                  </a:ext>
                </a:extLst>
              </a:tr>
              <a:tr h="340454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name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D</a:t>
                      </a:r>
                      <a:r>
                        <a:rPr lang="en-US" sz="11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vs 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D</a:t>
                      </a:r>
                      <a:r>
                        <a:rPr lang="en-US" sz="11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I</a:t>
                      </a:r>
                      <a:r>
                        <a:rPr lang="en-US" sz="11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vs 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D</a:t>
                      </a:r>
                      <a:r>
                        <a:rPr lang="en-US" sz="11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vs contro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D/ANI</a:t>
                      </a:r>
                      <a:r>
                        <a:rPr lang="en-US" sz="11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vs 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31681177"/>
                  </a:ext>
                </a:extLst>
              </a:tr>
              <a:tr h="18203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XA1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74083971"/>
                  </a:ext>
                </a:extLst>
              </a:tr>
              <a:tr h="18203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CS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83651111"/>
                  </a:ext>
                </a:extLst>
              </a:tr>
              <a:tr h="18203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LM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7579641"/>
                  </a:ext>
                </a:extLst>
              </a:tr>
              <a:tr h="18203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1QB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67646333"/>
                  </a:ext>
                </a:extLst>
              </a:tr>
              <a:tr h="18203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4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75144856"/>
                  </a:ext>
                </a:extLst>
              </a:tr>
              <a:tr h="18203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1A1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16381663"/>
                  </a:ext>
                </a:extLst>
              </a:tr>
              <a:tr h="18203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M124A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56201364"/>
                  </a:ext>
                </a:extLst>
              </a:tr>
              <a:tr h="18203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R1L4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81437053"/>
                  </a:ext>
                </a:extLst>
              </a:tr>
              <a:tr h="18203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NC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54102461"/>
                  </a:ext>
                </a:extLst>
              </a:tr>
              <a:tr h="18203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1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FAP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51370017"/>
                  </a:ext>
                </a:extLst>
              </a:tr>
              <a:tr h="18203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1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LA-A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19477849"/>
                  </a:ext>
                </a:extLst>
              </a:tr>
              <a:tr h="18203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1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P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65841379"/>
                  </a:ext>
                </a:extLst>
              </a:tr>
              <a:tr h="18203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1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AM1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06063057"/>
                  </a:ext>
                </a:extLst>
              </a:tr>
              <a:tr h="18203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1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IT1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73362875"/>
                  </a:ext>
                </a:extLst>
              </a:tr>
              <a:tr h="18203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1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IT2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51078471"/>
                  </a:ext>
                </a:extLst>
              </a:tr>
              <a:tr h="18203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1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IT3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66562451"/>
                  </a:ext>
                </a:extLst>
              </a:tr>
              <a:tr h="18203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1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SG15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1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32488254"/>
                  </a:ext>
                </a:extLst>
              </a:tr>
              <a:tr h="18203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1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TIH2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74071884"/>
                  </a:ext>
                </a:extLst>
              </a:tr>
              <a:tr h="18203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1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X1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36348921"/>
                  </a:ext>
                </a:extLst>
              </a:tr>
              <a:tr h="18203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2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QO1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87283467"/>
                  </a:ext>
                </a:extLst>
              </a:tr>
              <a:tr h="18203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2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AS2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1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52155154"/>
                  </a:ext>
                </a:extLst>
              </a:tr>
              <a:tr h="18203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2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GAP1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506391911"/>
                  </a:ext>
                </a:extLst>
              </a:tr>
              <a:tr h="18203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2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XDC2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164578196"/>
                  </a:ext>
                </a:extLst>
              </a:tr>
              <a:tr h="18203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2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MK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26761600"/>
                  </a:ext>
                </a:extLst>
              </a:tr>
              <a:tr h="18203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2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D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1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36754723"/>
                  </a:ext>
                </a:extLst>
              </a:tr>
              <a:tr h="18203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2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VALB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61002361"/>
                  </a:ext>
                </a:extLst>
              </a:tr>
              <a:tr h="18203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2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100A10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25658287"/>
                  </a:ext>
                </a:extLst>
              </a:tr>
              <a:tr h="18203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2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H3BP4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43635958"/>
                  </a:ext>
                </a:extLst>
              </a:tr>
              <a:tr h="18203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2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T1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35915123"/>
                  </a:ext>
                </a:extLst>
              </a:tr>
              <a:tr h="18203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3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BA8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 0.5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77228079"/>
                  </a:ext>
                </a:extLst>
              </a:tr>
            </a:tbl>
          </a:graphicData>
        </a:graphic>
      </p:graphicFrame>
      <p:sp>
        <p:nvSpPr>
          <p:cNvPr id="6" name="Rectangle 5"/>
          <p:cNvSpPr/>
          <p:nvPr/>
        </p:nvSpPr>
        <p:spPr>
          <a:xfrm>
            <a:off x="1241832" y="152651"/>
            <a:ext cx="576765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S6 Table. HAND was associated with significant upregulation of 30 proteins.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457673C-37D1-0B31-959B-21BDE1B9B928}"/>
              </a:ext>
            </a:extLst>
          </p:cNvPr>
          <p:cNvSpPr txBox="1"/>
          <p:nvPr/>
        </p:nvSpPr>
        <p:spPr>
          <a:xfrm flipH="1">
            <a:off x="1241832" y="6596004"/>
            <a:ext cx="345734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ote: The data represent the Log2 ratio to control.</a:t>
            </a:r>
          </a:p>
        </p:txBody>
      </p:sp>
    </p:spTree>
    <p:extLst>
      <p:ext uri="{BB962C8B-B14F-4D97-AF65-F5344CB8AC3E}">
        <p14:creationId xmlns:p14="http://schemas.microsoft.com/office/powerpoint/2010/main" val="17693672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2</Words>
  <Application>Microsoft Office PowerPoint</Application>
  <PresentationFormat>Widescreen</PresentationFormat>
  <Paragraphs>16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ang, Yuyang</dc:creator>
  <cp:lastModifiedBy>Tang, Yuyang</cp:lastModifiedBy>
  <cp:revision>1</cp:revision>
  <dcterms:created xsi:type="dcterms:W3CDTF">2025-07-28T20:01:41Z</dcterms:created>
  <dcterms:modified xsi:type="dcterms:W3CDTF">2025-07-28T20:02:16Z</dcterms:modified>
</cp:coreProperties>
</file>